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jpg" ContentType="image/jpeg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Default Extension="png" ContentType="image/png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Default Extension="jpeg" ContentType="image/jpeg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69" r:id="rId2"/>
    <p:sldId id="270" r:id="rId3"/>
    <p:sldId id="271" r:id="rId4"/>
    <p:sldId id="266" r:id="rId5"/>
    <p:sldId id="258" r:id="rId6"/>
    <p:sldId id="259" r:id="rId7"/>
    <p:sldId id="260" r:id="rId8"/>
    <p:sldId id="261" r:id="rId9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80908" autoAdjust="0"/>
  </p:normalViewPr>
  <p:slideViewPr>
    <p:cSldViewPr snapToGrid="0" snapToObjects="1">
      <p:cViewPr>
        <p:scale>
          <a:sx n="84" d="100"/>
          <a:sy n="84" d="100"/>
        </p:scale>
        <p:origin x="-156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17" Type="http://schemas.openxmlformats.org/officeDocument/2006/relationships/customXml" Target="../customXml/item3.xml"/><Relationship Id="rId2" Type="http://schemas.openxmlformats.org/officeDocument/2006/relationships/slide" Target="slides/slide1.xml"/><Relationship Id="rId16" Type="http://schemas.openxmlformats.org/officeDocument/2006/relationships/customXml" Target="../customXml/item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customXml" Target="../customXml/item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394BB8-A87E-C64D-BD05-41C55674B0F9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83915E-C7AD-4D42-8C52-15EC17E5E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3771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DB9F72-809B-488A-996A-C9E68F059F80}" type="slidenum">
              <a:rPr lang="en-AU" smtClean="0"/>
              <a:t>4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660518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DB9F72-809B-488A-996A-C9E68F059F80}" type="slidenum">
              <a:rPr lang="en-AU" smtClean="0"/>
              <a:t>5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5601043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1200" b="1" u="none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DB9F72-809B-488A-996A-C9E68F059F80}" type="slidenum">
              <a:rPr lang="en-AU" smtClean="0"/>
              <a:t>6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240846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1200" b="1" u="none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DB9F72-809B-488A-996A-C9E68F059F80}" type="slidenum">
              <a:rPr lang="en-AU" smtClean="0"/>
              <a:t>7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4993482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1200" b="1" u="none" kern="1200" baseline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AU" altLang="en-US" sz="1200" dirty="0" smtClean="0">
              <a:solidFill>
                <a:prstClr val="black"/>
              </a:solidFill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DB9F72-809B-488A-996A-C9E68F059F80}" type="slidenum">
              <a:rPr lang="en-AU" smtClean="0"/>
              <a:t>8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0028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F48F7-5C66-C848-806A-BF96DCF41020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B2140-5C7D-214F-BC19-90CF390891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104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F48F7-5C66-C848-806A-BF96DCF41020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B2140-5C7D-214F-BC19-90CF390891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050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F48F7-5C66-C848-806A-BF96DCF41020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B2140-5C7D-214F-BC19-90CF390891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806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F48F7-5C66-C848-806A-BF96DCF41020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B2140-5C7D-214F-BC19-90CF390891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440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F48F7-5C66-C848-806A-BF96DCF41020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B2140-5C7D-214F-BC19-90CF390891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537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F48F7-5C66-C848-806A-BF96DCF41020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B2140-5C7D-214F-BC19-90CF390891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913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F48F7-5C66-C848-806A-BF96DCF41020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B2140-5C7D-214F-BC19-90CF390891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747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F48F7-5C66-C848-806A-BF96DCF41020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B2140-5C7D-214F-BC19-90CF390891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029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F48F7-5C66-C848-806A-BF96DCF41020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B2140-5C7D-214F-BC19-90CF390891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7229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F48F7-5C66-C848-806A-BF96DCF41020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B2140-5C7D-214F-BC19-90CF390891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359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8F48F7-5C66-C848-806A-BF96DCF41020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B2140-5C7D-214F-BC19-90CF390891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996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F48F7-5C66-C848-806A-BF96DCF41020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6B2140-5C7D-214F-BC19-90CF390891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508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6667"/>
          <a:stretch/>
        </p:blipFill>
        <p:spPr>
          <a:xfrm>
            <a:off x="148590" y="102871"/>
            <a:ext cx="6537960" cy="87172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39069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857" b="33341"/>
          <a:stretch/>
        </p:blipFill>
        <p:spPr>
          <a:xfrm>
            <a:off x="148590" y="101596"/>
            <a:ext cx="6537960" cy="88279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61766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300" b="29"/>
          <a:stretch/>
        </p:blipFill>
        <p:spPr>
          <a:xfrm>
            <a:off x="116840" y="11288"/>
            <a:ext cx="6537960" cy="87940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87930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/>
          <p:cNvSpPr/>
          <p:nvPr/>
        </p:nvSpPr>
        <p:spPr>
          <a:xfrm>
            <a:off x="-4526755" y="4943340"/>
            <a:ext cx="476250" cy="10312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80628" y="759201"/>
            <a:ext cx="677737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S1. </a:t>
            </a:r>
            <a:r>
              <a:rPr lang="en-AU" sz="1400" b="1" i="1" dirty="0" smtClean="0"/>
              <a:t>H</a:t>
            </a:r>
            <a:r>
              <a:rPr lang="en-AU" sz="1400" b="1" i="1" dirty="0"/>
              <a:t>. armigera </a:t>
            </a:r>
            <a:r>
              <a:rPr lang="en-AU" sz="1400" b="1" dirty="0"/>
              <a:t>Acetylcholinesterase sequence. </a:t>
            </a:r>
            <a:r>
              <a:rPr lang="en-AU" sz="1400" dirty="0"/>
              <a:t>Alignment of Acetylcholinesterase nucleotide sequence in </a:t>
            </a:r>
            <a:r>
              <a:rPr lang="en-AU" sz="1400" i="1" dirty="0" smtClean="0"/>
              <a:t>H. </a:t>
            </a:r>
            <a:r>
              <a:rPr lang="en-AU" sz="1400" i="1" dirty="0"/>
              <a:t>sapiens</a:t>
            </a:r>
            <a:r>
              <a:rPr lang="en-AU" sz="1400" dirty="0"/>
              <a:t> </a:t>
            </a:r>
            <a:r>
              <a:rPr lang="en-AU" sz="1400" dirty="0" smtClean="0"/>
              <a:t>(M55040</a:t>
            </a:r>
            <a:r>
              <a:rPr lang="en-AU" sz="1400" dirty="0"/>
              <a:t>), </a:t>
            </a:r>
            <a:r>
              <a:rPr lang="en-AU" sz="1400" i="1" dirty="0"/>
              <a:t>H. </a:t>
            </a:r>
            <a:r>
              <a:rPr lang="en-AU" sz="1400" i="1" dirty="0" err="1"/>
              <a:t>zea</a:t>
            </a:r>
            <a:r>
              <a:rPr lang="en-AU" sz="1400" dirty="0"/>
              <a:t>, </a:t>
            </a:r>
            <a:r>
              <a:rPr lang="en-AU" sz="1400" i="1" dirty="0"/>
              <a:t>H. armigera </a:t>
            </a:r>
            <a:r>
              <a:rPr lang="en-AU" sz="1400" i="1" dirty="0" smtClean="0"/>
              <a:t>(ACE2</a:t>
            </a:r>
            <a:r>
              <a:rPr lang="en-AU" sz="1400" i="1" dirty="0"/>
              <a:t>; </a:t>
            </a:r>
            <a:r>
              <a:rPr lang="en-AU" sz="1400" dirty="0"/>
              <a:t>AF369793 </a:t>
            </a:r>
            <a:r>
              <a:rPr lang="en-AU" sz="1400" dirty="0" smtClean="0"/>
              <a:t>and </a:t>
            </a:r>
            <a:r>
              <a:rPr lang="en-AU" sz="1400" i="1" dirty="0" smtClean="0"/>
              <a:t>ACE1 </a:t>
            </a:r>
            <a:r>
              <a:rPr lang="en-AU" sz="1400" dirty="0"/>
              <a:t>AY142325</a:t>
            </a:r>
            <a:r>
              <a:rPr lang="en-AU" sz="1400" dirty="0" smtClean="0"/>
              <a:t>.</a:t>
            </a:r>
            <a:r>
              <a:rPr lang="en-AU" sz="1400" i="1" dirty="0" smtClean="0"/>
              <a:t>)</a:t>
            </a:r>
            <a:r>
              <a:rPr lang="en-AU" sz="1400" dirty="0" smtClean="0"/>
              <a:t>. </a:t>
            </a:r>
            <a:r>
              <a:rPr lang="en-AU" sz="1400" dirty="0"/>
              <a:t>Conserved residues are enclosed in black /grey boxes, hairpin target </a:t>
            </a:r>
            <a:r>
              <a:rPr lang="en-AU" sz="1400" dirty="0" smtClean="0"/>
              <a:t>region is </a:t>
            </a:r>
            <a:r>
              <a:rPr lang="en-AU" sz="1400" dirty="0"/>
              <a:t>indicated in yellow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5762223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479" r="50453" b="7933"/>
          <a:stretch/>
        </p:blipFill>
        <p:spPr>
          <a:xfrm>
            <a:off x="512675" y="949060"/>
            <a:ext cx="5954225" cy="511021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05287" y="7054682"/>
            <a:ext cx="6601199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S2</a:t>
            </a:r>
            <a:r>
              <a:rPr lang="en-US" sz="1400" b="1" dirty="0"/>
              <a:t> </a:t>
            </a:r>
            <a:r>
              <a:rPr lang="en-AU" sz="1400" dirty="0" smtClean="0"/>
              <a:t>Data </a:t>
            </a:r>
            <a:r>
              <a:rPr lang="en-AU" sz="1400" dirty="0"/>
              <a:t>from sequences found to be effective in dsRNA feeding </a:t>
            </a:r>
            <a:r>
              <a:rPr lang="en-AU" sz="1400" dirty="0" smtClean="0"/>
              <a:t>experiments </a:t>
            </a:r>
            <a:endParaRPr lang="en-AU" sz="1400" dirty="0"/>
          </a:p>
          <a:p>
            <a:r>
              <a:rPr lang="en-US" sz="1000" dirty="0" smtClean="0"/>
              <a:t>Bachman</a:t>
            </a:r>
            <a:r>
              <a:rPr lang="en-US" sz="1000" dirty="0"/>
              <a:t>, P.M., </a:t>
            </a:r>
            <a:r>
              <a:rPr lang="en-US" sz="1000" dirty="0" err="1"/>
              <a:t>Bolognesi</a:t>
            </a:r>
            <a:r>
              <a:rPr lang="en-US" sz="1000" dirty="0"/>
              <a:t>, R., </a:t>
            </a:r>
            <a:r>
              <a:rPr lang="en-US" sz="1000" dirty="0" err="1"/>
              <a:t>Moar</a:t>
            </a:r>
            <a:r>
              <a:rPr lang="en-US" sz="1000" dirty="0"/>
              <a:t>, W.J., Mueller, G.M., Paradise, M.S., </a:t>
            </a:r>
            <a:r>
              <a:rPr lang="en-US" sz="1000" dirty="0" err="1"/>
              <a:t>Ramaseshadri</a:t>
            </a:r>
            <a:r>
              <a:rPr lang="en-US" sz="1000" dirty="0"/>
              <a:t>, P., Tan, J., </a:t>
            </a:r>
            <a:r>
              <a:rPr lang="en-US" sz="1000" dirty="0" err="1"/>
              <a:t>Uffman</a:t>
            </a:r>
            <a:r>
              <a:rPr lang="en-US" sz="1000" dirty="0"/>
              <a:t>, J.P., Warren, J., Wiggins, B.E. and Levine, S.L. (2013) Characterization of the spectrum of insecticidal activity of a double-stranded RNA with targeted activity against Western Corn Rootworm (</a:t>
            </a:r>
            <a:r>
              <a:rPr lang="en-US" sz="1000" dirty="0" err="1"/>
              <a:t>Diabrotica</a:t>
            </a:r>
            <a:r>
              <a:rPr lang="en-US" sz="1000" dirty="0"/>
              <a:t> </a:t>
            </a:r>
            <a:r>
              <a:rPr lang="en-US" sz="1000" dirty="0" err="1"/>
              <a:t>virgifera</a:t>
            </a:r>
            <a:r>
              <a:rPr lang="en-US" sz="1000" dirty="0"/>
              <a:t> </a:t>
            </a:r>
            <a:r>
              <a:rPr lang="en-US" sz="1000" dirty="0" err="1"/>
              <a:t>virgifera</a:t>
            </a:r>
            <a:r>
              <a:rPr lang="en-US" sz="1000" dirty="0"/>
              <a:t> </a:t>
            </a:r>
            <a:r>
              <a:rPr lang="en-US" sz="1000" dirty="0" err="1"/>
              <a:t>LeConte</a:t>
            </a:r>
            <a:r>
              <a:rPr lang="en-US" sz="1000" dirty="0"/>
              <a:t>). </a:t>
            </a:r>
            <a:r>
              <a:rPr lang="en-US" sz="1000" i="1" dirty="0"/>
              <a:t>Transgenic Res</a:t>
            </a:r>
            <a:r>
              <a:rPr lang="en-US" sz="1000" dirty="0"/>
              <a:t> </a:t>
            </a:r>
            <a:r>
              <a:rPr lang="en-US" sz="1000" b="1" dirty="0"/>
              <a:t>22</a:t>
            </a:r>
            <a:r>
              <a:rPr lang="en-US" sz="1000" dirty="0"/>
              <a:t>, 1207-1222.</a:t>
            </a:r>
            <a:endParaRPr lang="en-AU" sz="1000" dirty="0"/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3730914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395" y="166457"/>
            <a:ext cx="5655784" cy="3625354"/>
          </a:xfrm>
          <a:prstGeom prst="rect">
            <a:avLst/>
          </a:prstGeom>
        </p:spPr>
      </p:pic>
      <p:grpSp>
        <p:nvGrpSpPr>
          <p:cNvPr id="2" name="Group 1"/>
          <p:cNvGrpSpPr/>
          <p:nvPr/>
        </p:nvGrpSpPr>
        <p:grpSpPr>
          <a:xfrm>
            <a:off x="708742" y="1433689"/>
            <a:ext cx="4091390" cy="2358122"/>
            <a:chOff x="35496" y="5020192"/>
            <a:chExt cx="5455187" cy="1608830"/>
          </a:xfrm>
        </p:grpSpPr>
        <p:sp>
          <p:nvSpPr>
            <p:cNvPr id="4" name="TextBox 3"/>
            <p:cNvSpPr txBox="1"/>
            <p:nvPr/>
          </p:nvSpPr>
          <p:spPr>
            <a:xfrm>
              <a:off x="267883" y="5020192"/>
              <a:ext cx="51766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T1</a:t>
              </a:r>
              <a:endParaRPr lang="en-AU" sz="16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5496" y="6375106"/>
              <a:ext cx="51766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T3</a:t>
              </a:r>
              <a:endParaRPr lang="en-AU" sz="16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173855" y="6345046"/>
              <a:ext cx="73994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T4-1</a:t>
              </a:r>
              <a:endParaRPr lang="en-AU" sz="16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750736" y="6323545"/>
              <a:ext cx="73994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T4-2</a:t>
              </a:r>
              <a:endParaRPr lang="en-AU" sz="16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491904" y="5020192"/>
              <a:ext cx="51766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T2</a:t>
              </a:r>
              <a:endParaRPr lang="en-AU" sz="16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305365" y="5020192"/>
              <a:ext cx="62239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WT</a:t>
              </a:r>
              <a:endParaRPr lang="en-AU" sz="1600" dirty="0"/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25526" y="4023182"/>
            <a:ext cx="683247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>
              <a:defRPr/>
            </a:pPr>
            <a:r>
              <a:rPr lang="en-US" sz="1400" b="1" dirty="0" smtClean="0"/>
              <a:t>Figure S3. Seed </a:t>
            </a:r>
            <a:r>
              <a:rPr lang="en-US" sz="1400" b="1" dirty="0"/>
              <a:t>assays confirming </a:t>
            </a:r>
            <a:r>
              <a:rPr lang="en-US" sz="1400" b="1" dirty="0" err="1"/>
              <a:t>homoplasmy</a:t>
            </a:r>
            <a:r>
              <a:rPr lang="en-US" sz="1400" b="1" dirty="0"/>
              <a:t> of plants regenerated from chloroplast transformants. </a:t>
            </a:r>
            <a:r>
              <a:rPr lang="en-AU" sz="1400" dirty="0"/>
              <a:t>Four generations (T1 –T4) of </a:t>
            </a:r>
            <a:r>
              <a:rPr lang="en-AU" sz="1400" dirty="0" err="1"/>
              <a:t>hpACE</a:t>
            </a:r>
            <a:r>
              <a:rPr lang="en-AU" sz="1400" dirty="0"/>
              <a:t>-c </a:t>
            </a:r>
            <a:r>
              <a:rPr lang="en-AU" sz="1400" dirty="0" smtClean="0"/>
              <a:t>lines </a:t>
            </a:r>
            <a:r>
              <a:rPr lang="en-AU" sz="1400" dirty="0"/>
              <a:t>after 4 weeks on germination media </a:t>
            </a:r>
            <a:r>
              <a:rPr lang="en-AU" sz="1400" dirty="0" smtClean="0"/>
              <a:t>supplemented </a:t>
            </a:r>
            <a:r>
              <a:rPr lang="en-AU" sz="1400" dirty="0"/>
              <a:t>with spectinomycin (500mg/L) </a:t>
            </a:r>
          </a:p>
        </p:txBody>
      </p:sp>
    </p:spTree>
    <p:extLst>
      <p:ext uri="{BB962C8B-B14F-4D97-AF65-F5344CB8AC3E}">
        <p14:creationId xmlns:p14="http://schemas.microsoft.com/office/powerpoint/2010/main" val="9643343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6420641"/>
              </p:ext>
            </p:extLst>
          </p:nvPr>
        </p:nvGraphicFramePr>
        <p:xfrm>
          <a:off x="948267" y="1883701"/>
          <a:ext cx="5328355" cy="1778000"/>
        </p:xfrm>
        <a:graphic>
          <a:graphicData uri="http://schemas.openxmlformats.org/drawingml/2006/table">
            <a:tbl>
              <a:tblPr/>
              <a:tblGrid>
                <a:gridCol w="828749"/>
                <a:gridCol w="496917"/>
                <a:gridCol w="810129"/>
                <a:gridCol w="707078"/>
                <a:gridCol w="828494"/>
                <a:gridCol w="828494"/>
                <a:gridCol w="828494"/>
              </a:tblGrid>
              <a:tr h="254000">
                <a:tc rowSpan="2" gridSpan="2">
                  <a:txBody>
                    <a:bodyPr/>
                    <a:lstStyle/>
                    <a:p>
                      <a:pPr algn="ctr" fontAlgn="b"/>
                      <a:endParaRPr lang="en-AU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4" marR="7144" marT="1270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7144" marR="7144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p</a:t>
                      </a:r>
                      <a:r>
                        <a:rPr lang="en-AU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AU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E-c</a:t>
                      </a:r>
                      <a:endParaRPr lang="en-AU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p</a:t>
                      </a:r>
                      <a:r>
                        <a:rPr lang="en-AU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AU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E-n</a:t>
                      </a:r>
                      <a:endParaRPr lang="en-AU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</a:tr>
              <a:tr h="254000">
                <a:tc gridSpan="2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4000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T</a:t>
                      </a:r>
                    </a:p>
                  </a:txBody>
                  <a:tcPr marL="7144" marR="7144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CED0"/>
                    </a:solidFill>
                  </a:tcPr>
                </a:tc>
              </a:tr>
              <a:tr h="254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AU" sz="1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p</a:t>
                      </a:r>
                      <a:r>
                        <a:rPr lang="en-AU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AU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E-c</a:t>
                      </a:r>
                      <a:endParaRPr lang="en-AU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4" marR="7144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7144" marR="7144" marT="1270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9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4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4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</a:tr>
              <a:tr h="25400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7144" marR="7144" marT="1270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9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</a:tr>
              <a:tr h="254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AU" sz="1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p</a:t>
                      </a:r>
                      <a:r>
                        <a:rPr lang="en-AU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AU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E-n</a:t>
                      </a:r>
                      <a:endParaRPr lang="en-AU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144" marR="7144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7144" marR="7144" marT="1270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4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4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6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FF2"/>
                    </a:solidFill>
                  </a:tcPr>
                </a:tc>
              </a:tr>
              <a:tr h="25400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7144" marR="7144" marT="1270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CE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6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F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7144" marR="7144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0" y="3883018"/>
            <a:ext cx="675722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Table S1. </a:t>
            </a:r>
            <a:r>
              <a:rPr lang="en-AU" sz="1400" b="1" dirty="0"/>
              <a:t>Significant differences of </a:t>
            </a:r>
            <a:r>
              <a:rPr lang="en-AU" sz="1400" b="1" i="1" dirty="0"/>
              <a:t>H. armigera </a:t>
            </a:r>
            <a:r>
              <a:rPr lang="en-AU" sz="1400" b="1" dirty="0"/>
              <a:t>weight after feeding on WT, transplastomic (</a:t>
            </a:r>
            <a:r>
              <a:rPr lang="en-AU" sz="1400" b="1" dirty="0" err="1" smtClean="0"/>
              <a:t>hpACE</a:t>
            </a:r>
            <a:r>
              <a:rPr lang="en-AU" sz="1400" b="1" dirty="0" smtClean="0"/>
              <a:t>-c) </a:t>
            </a:r>
            <a:r>
              <a:rPr lang="en-AU" sz="1400" b="1" dirty="0"/>
              <a:t>and nuclear (</a:t>
            </a:r>
            <a:r>
              <a:rPr lang="en-AU" sz="1400" b="1" dirty="0" err="1" smtClean="0"/>
              <a:t>hpACE</a:t>
            </a:r>
            <a:r>
              <a:rPr lang="en-AU" sz="1400" b="1" dirty="0" smtClean="0"/>
              <a:t>-n</a:t>
            </a:r>
            <a:r>
              <a:rPr lang="en-AU" sz="1400" b="1" dirty="0"/>
              <a:t>) Transformants. </a:t>
            </a:r>
            <a:r>
              <a:rPr lang="en-AU" sz="1400" dirty="0"/>
              <a:t>Significant differences were identified by analysis of variance using ANOVA. Red and light red indicates a  non significant difference when P&gt;0.5 and 0.1 &lt;P&lt;0.5 respectively. All data indicated in white indicate significant differences.</a:t>
            </a: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91825267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319834"/>
              </p:ext>
            </p:extLst>
          </p:nvPr>
        </p:nvGraphicFramePr>
        <p:xfrm>
          <a:off x="206361" y="1019606"/>
          <a:ext cx="6484237" cy="2334061"/>
        </p:xfrm>
        <a:graphic>
          <a:graphicData uri="http://schemas.openxmlformats.org/drawingml/2006/table">
            <a:tbl>
              <a:tblPr firstRow="1" firstCol="1"/>
              <a:tblGrid>
                <a:gridCol w="525159"/>
                <a:gridCol w="2857500"/>
                <a:gridCol w="3101578"/>
              </a:tblGrid>
              <a:tr h="23368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2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Name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2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Sequence (5’ to 3’)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3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pplication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637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f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/>
                        <a:t>CGAAAAGGAATCTATTGATTCTCTCCCAATTGG</a:t>
                      </a:r>
                      <a:endParaRPr lang="en-AU" sz="1300" dirty="0" smtClean="0">
                        <a:solidFill>
                          <a:srgbClr val="000000"/>
                        </a:solidFill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300" b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Binds in </a:t>
                      </a:r>
                      <a:r>
                        <a:rPr lang="en-AU" sz="1300" b="0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trnI</a:t>
                      </a:r>
                      <a:endParaRPr lang="en-AU" sz="1300" b="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3368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1r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CTCGTCTGACGGGAATCCCAATATG</a:t>
                      </a: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3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Binds in </a:t>
                      </a:r>
                      <a:r>
                        <a:rPr lang="en-AU" sz="1300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pdk</a:t>
                      </a:r>
                      <a:r>
                        <a:rPr lang="en-AU" sz="13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intron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8032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f 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ACCAGGTCTCAGGAGCATGGAGTTGGATGACAGGA</a:t>
                      </a:r>
                      <a:endParaRPr lang="en-AU" sz="12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F primer, Acetylcholinesterase hairpin 189pb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8032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2r 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n-AU" sz="12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CCAGGTCTCCTCGAGCTGACGGGAATCCCAATATG</a:t>
                      </a:r>
                      <a:endParaRPr lang="en-AU" sz="12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Calibri"/>
                          <a:cs typeface="Times New Roman"/>
                        </a:rPr>
                        <a:t>R primer, Acetylcholinesterase hairpin 189bp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8032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3f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n-AU" sz="1200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  <a:ea typeface="Calibri"/>
                          <a:cs typeface="Times New Roman"/>
                        </a:rPr>
                        <a:t>TGATAGATCATGTCATTGTG</a:t>
                      </a:r>
                      <a:endParaRPr lang="en-US" sz="1300" dirty="0" smtClean="0">
                        <a:latin typeface="+mj-lt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3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Binds in </a:t>
                      </a:r>
                      <a:r>
                        <a:rPr lang="en-AU" sz="1300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pdk</a:t>
                      </a:r>
                      <a:r>
                        <a:rPr lang="en-AU" sz="1300" baseline="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 intron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073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3r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n-US" sz="1200" b="0" dirty="0" smtClean="0"/>
                        <a:t>TCCAACCCGTAATCGCAACG</a:t>
                      </a: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AU" sz="13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Binds in </a:t>
                      </a:r>
                      <a:r>
                        <a:rPr lang="en-AU" sz="1300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trnA</a:t>
                      </a:r>
                      <a:endParaRPr lang="en-AU" sz="1300" dirty="0">
                        <a:solidFill>
                          <a:srgbClr val="000000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7856" marR="3785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74115" y="3572572"/>
            <a:ext cx="275646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/>
            <a:r>
              <a:rPr lang="en-US" sz="1400" b="1" dirty="0" smtClean="0"/>
              <a:t>Table S2. </a:t>
            </a:r>
            <a:r>
              <a:rPr lang="en-AU" altLang="en-US" sz="1400" dirty="0" smtClean="0">
                <a:solidFill>
                  <a:srgbClr val="000000"/>
                </a:solidFill>
                <a:latin typeface="Calibri" pitchFamily="34" charset="0"/>
                <a:ea typeface="Times New Roman" pitchFamily="18" charset="0"/>
                <a:cs typeface="Times New Roman" pitchFamily="18" charset="0"/>
              </a:rPr>
              <a:t>Primers </a:t>
            </a:r>
            <a:r>
              <a:rPr lang="en-AU" altLang="en-US" sz="1400" dirty="0">
                <a:solidFill>
                  <a:srgbClr val="000000"/>
                </a:solidFill>
                <a:latin typeface="Calibri" pitchFamily="34" charset="0"/>
                <a:ea typeface="Times New Roman" pitchFamily="18" charset="0"/>
                <a:cs typeface="Times New Roman" pitchFamily="18" charset="0"/>
              </a:rPr>
              <a:t>used in this study</a:t>
            </a:r>
            <a:endParaRPr lang="en-AU" altLang="en-US" sz="1400" dirty="0">
              <a:solidFill>
                <a:prstClr val="black"/>
              </a:solidFill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89081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028C09C9D97D24780058C99077D8847" ma:contentTypeVersion="7" ma:contentTypeDescription="Create a new document." ma:contentTypeScope="" ma:versionID="0132886fdf3e2c25019eb3cd8923805d">
  <xsd:schema xmlns:xsd="http://www.w3.org/2001/XMLSchema" xmlns:p="http://schemas.microsoft.com/office/2006/metadata/properties" xmlns:ns2="39616538-2d66-4de6-9e6e-2b8794b75252" targetNamespace="http://schemas.microsoft.com/office/2006/metadata/properties" ma:root="true" ma:fieldsID="afb14a4498c4490eaa362745f3dd1134" ns2:_="">
    <xsd:import namespace="39616538-2d66-4de6-9e6e-2b8794b7525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9616538-2d66-4de6-9e6e-2b8794b7525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39616538-2d66-4de6-9e6e-2b8794b75252">Presentation</DocumentType>
    <TitleName xmlns="39616538-2d66-4de6-9e6e-2b8794b75252">Presentation 1.PPTX</TitleName>
    <Checked_x0020_Out_x0020_To xmlns="39616538-2d66-4de6-9e6e-2b8794b75252">
      <UserInfo>
        <DisplayName/>
        <AccountId xsi:nil="true"/>
        <AccountType/>
      </UserInfo>
    </Checked_x0020_Out_x0020_To>
    <FileFormat xmlns="39616538-2d66-4de6-9e6e-2b8794b75252">PPTX</FileFormat>
    <DocumentId xmlns="39616538-2d66-4de6-9e6e-2b8794b75252">Presentation 1.PPTX</DocumentId>
    <StageName xmlns="39616538-2d66-4de6-9e6e-2b8794b75252" xsi:nil="true"/>
    <IsDeleted xmlns="39616538-2d66-4de6-9e6e-2b8794b75252">false</IsDeleted>
  </documentManagement>
</p:properties>
</file>

<file path=customXml/itemProps1.xml><?xml version="1.0" encoding="utf-8"?>
<ds:datastoreItem xmlns:ds="http://schemas.openxmlformats.org/officeDocument/2006/customXml" ds:itemID="{C602A669-0D63-46D3-9B0D-C900C02F1A42}"/>
</file>

<file path=customXml/itemProps2.xml><?xml version="1.0" encoding="utf-8"?>
<ds:datastoreItem xmlns:ds="http://schemas.openxmlformats.org/officeDocument/2006/customXml" ds:itemID="{1D44D6EA-7AA5-477C-884D-8DD78A88CE29}"/>
</file>

<file path=customXml/itemProps3.xml><?xml version="1.0" encoding="utf-8"?>
<ds:datastoreItem xmlns:ds="http://schemas.openxmlformats.org/officeDocument/2006/customXml" ds:itemID="{A2B6F974-BCC3-41CE-9D90-60AB330BBFFE}"/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355</Words>
  <Application>Microsoft Office PowerPoint</Application>
  <PresentationFormat>On-screen Show (4:3)</PresentationFormat>
  <Paragraphs>82</Paragraphs>
  <Slides>8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JJfamil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a Bally</dc:creator>
  <cp:lastModifiedBy>Julia Bally</cp:lastModifiedBy>
  <cp:revision>19</cp:revision>
  <dcterms:created xsi:type="dcterms:W3CDTF">2016-03-21T13:05:46Z</dcterms:created>
  <dcterms:modified xsi:type="dcterms:W3CDTF">2016-07-15T02:34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028C09C9D97D24780058C99077D8847</vt:lpwstr>
  </property>
</Properties>
</file>